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0" r:id="rId2"/>
    <p:sldId id="291" r:id="rId3"/>
    <p:sldId id="299" r:id="rId4"/>
    <p:sldId id="280" r:id="rId5"/>
    <p:sldId id="281" r:id="rId6"/>
    <p:sldId id="274" r:id="rId7"/>
    <p:sldId id="292" r:id="rId8"/>
    <p:sldId id="293" r:id="rId9"/>
    <p:sldId id="267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BDEF"/>
    <a:srgbClr val="DFE4F8"/>
    <a:srgbClr val="C7DFCA"/>
    <a:srgbClr val="9BD9A2"/>
    <a:srgbClr val="F287A1"/>
    <a:srgbClr val="FAD1DB"/>
    <a:srgbClr val="D473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28" autoAdjust="0"/>
    <p:restoredTop sz="96395" autoAdjust="0"/>
  </p:normalViewPr>
  <p:slideViewPr>
    <p:cSldViewPr snapToGrid="0">
      <p:cViewPr>
        <p:scale>
          <a:sx n="150" d="100"/>
          <a:sy n="150" d="100"/>
        </p:scale>
        <p:origin x="1980" y="-8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\Desktop%201\Dr.%20Anas%20AbdulRahman\my%20metabolomic%20MDA%20restore%20project\result\WB%20quantific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ithout ZEB1 &amp; SLUG`'!$I$2,'without ZEB1 &amp; SLUG`'!$I$8,'without ZEB1 &amp; SLUG`'!$I$15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868958238827095</c:v>
                  </c:pt>
                  <c:pt idx="2">
                    <c:v>0.24089827680775477</c:v>
                  </c:pt>
                </c:numCache>
              </c:numRef>
            </c:plus>
            <c:minus>
              <c:numRef>
                <c:f>('without ZEB1 &amp; SLUG`'!$I$2,'without ZEB1 &amp; SLUG`'!$I$8,'without ZEB1 &amp; SLUG`'!$I$15)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868958238827095</c:v>
                  </c:pt>
                  <c:pt idx="2">
                    <c:v>0.24089827680775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without ZEB1 &amp; SLUG`'!$Q$15:$Q$17</c:f>
              <c:numCache>
                <c:formatCode>General</c:formatCode>
                <c:ptCount val="3"/>
                <c:pt idx="0">
                  <c:v>1</c:v>
                </c:pt>
                <c:pt idx="1">
                  <c:v>1.7816598154141294</c:v>
                </c:pt>
                <c:pt idx="2">
                  <c:v>0.45642260786753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B4-44B0-9A0F-2923C094A901}"/>
            </c:ext>
          </c:extLst>
        </c:ser>
        <c:ser>
          <c:idx val="1"/>
          <c:order val="1"/>
          <c:spPr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ithout ZEB1 &amp; SLUG`'!$I$3,'without ZEB1 &amp; SLUG`'!$I$9,'without ZEB1 &amp; SLUG`'!$I$16,'without ZEB1 &amp; SLUG`'!$I$27,'without ZEB1 &amp; SLUG`'!$I$38)</c:f>
                <c:numCache>
                  <c:formatCode>General</c:formatCode>
                  <c:ptCount val="5"/>
                  <c:pt idx="0">
                    <c:v>3.1594278531079704E-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plus>
            <c:minus>
              <c:numRef>
                <c:f>('without ZEB1 &amp; SLUG`'!$I$3,'without ZEB1 &amp; SLUG`'!$I$9,'without ZEB1 &amp; SLUG`'!$I$16,'without ZEB1 &amp; SLUG`'!$I$27,'without ZEB1 &amp; SLUG`'!$I$38)</c:f>
                <c:numCache>
                  <c:formatCode>General</c:formatCode>
                  <c:ptCount val="5"/>
                  <c:pt idx="0">
                    <c:v>3.1594278531079704E-3</c:v>
                  </c:pt>
                  <c:pt idx="1">
                    <c:v>0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without ZEB1 &amp; SLUG`'!$R$15:$R$17</c:f>
              <c:numCache>
                <c:formatCode>General</c:formatCode>
                <c:ptCount val="3"/>
                <c:pt idx="0">
                  <c:v>2.9168199410769071E-3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B4-44B0-9A0F-2923C094A901}"/>
            </c:ext>
          </c:extLst>
        </c:ser>
        <c:ser>
          <c:idx val="2"/>
          <c:order val="2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without ZEB1 &amp; SLUG`'!$I$4,'without ZEB1 &amp; SLUG`'!$I$10,'without ZEB1 &amp; SLUG`'!$I$17)</c:f>
                <c:numCache>
                  <c:formatCode>General</c:formatCode>
                  <c:ptCount val="3"/>
                  <c:pt idx="0">
                    <c:v>0.52818315381237435</c:v>
                  </c:pt>
                  <c:pt idx="1">
                    <c:v>6.8272499119081842E-2</c:v>
                  </c:pt>
                  <c:pt idx="2">
                    <c:v>3.8586163756713421E-2</c:v>
                  </c:pt>
                </c:numCache>
              </c:numRef>
            </c:plus>
            <c:minus>
              <c:numRef>
                <c:f>('without ZEB1 &amp; SLUG`'!$I$4,'without ZEB1 &amp; SLUG`'!$I$10,'without ZEB1 &amp; SLUG`'!$I$17)</c:f>
                <c:numCache>
                  <c:formatCode>General</c:formatCode>
                  <c:ptCount val="3"/>
                  <c:pt idx="0">
                    <c:v>0.52818315381237435</c:v>
                  </c:pt>
                  <c:pt idx="1">
                    <c:v>6.8272499119081842E-2</c:v>
                  </c:pt>
                  <c:pt idx="2">
                    <c:v>3.85861637567134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without ZEB1 &amp; SLUG`'!$S$15:$S$17</c:f>
              <c:numCache>
                <c:formatCode>General</c:formatCode>
                <c:ptCount val="3"/>
                <c:pt idx="0">
                  <c:v>1.3232071698930403</c:v>
                </c:pt>
                <c:pt idx="1">
                  <c:v>1.2039232785178633</c:v>
                </c:pt>
                <c:pt idx="2">
                  <c:v>0.352215856073373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DB4-44B0-9A0F-2923C094A9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3794496"/>
        <c:axId val="1203789920"/>
      </c:barChart>
      <c:catAx>
        <c:axId val="1203794496"/>
        <c:scaling>
          <c:orientation val="minMax"/>
        </c:scaling>
        <c:delete val="1"/>
        <c:axPos val="b"/>
        <c:majorTickMark val="none"/>
        <c:minorTickMark val="none"/>
        <c:tickLblPos val="nextTo"/>
        <c:crossAx val="1203789920"/>
        <c:crosses val="autoZero"/>
        <c:auto val="1"/>
        <c:lblAlgn val="ctr"/>
        <c:lblOffset val="100"/>
        <c:noMultiLvlLbl val="0"/>
      </c:catAx>
      <c:valAx>
        <c:axId val="1203789920"/>
        <c:scaling>
          <c:orientation val="minMax"/>
          <c:max val="3.5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03794496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421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9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711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109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6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848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539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695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12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145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279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16BDC-C00D-4C22-9954-E6F6F39E1F43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8C08FB-5F1B-43BC-A3A3-4ACCB5B30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325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chart" Target="../charts/chart1.xml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55184" y="7620"/>
            <a:ext cx="2163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 1A and 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5614" y="67076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F3B01EFF-C8D7-3517-CDDE-D08681E7270D}"/>
              </a:ext>
            </a:extLst>
          </p:cNvPr>
          <p:cNvSpPr txBox="1"/>
          <p:nvPr/>
        </p:nvSpPr>
        <p:spPr>
          <a:xfrm>
            <a:off x="2325099" y="1751237"/>
            <a:ext cx="9089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menti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9A74195-6126-5BD6-216A-9381AC4B05C1}"/>
              </a:ext>
            </a:extLst>
          </p:cNvPr>
          <p:cNvSpPr txBox="1"/>
          <p:nvPr/>
        </p:nvSpPr>
        <p:spPr>
          <a:xfrm>
            <a:off x="2318749" y="1201349"/>
            <a:ext cx="685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BCC7DC3-F0AB-66F9-F200-7C958AAD9F59}"/>
              </a:ext>
            </a:extLst>
          </p:cNvPr>
          <p:cNvSpPr txBox="1"/>
          <p:nvPr/>
        </p:nvSpPr>
        <p:spPr>
          <a:xfrm>
            <a:off x="2325352" y="2246807"/>
            <a:ext cx="1003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180"/>
          <p:cNvSpPr>
            <a:spLocks noChangeArrowheads="1"/>
          </p:cNvSpPr>
          <p:nvPr/>
        </p:nvSpPr>
        <p:spPr bwMode="auto">
          <a:xfrm>
            <a:off x="799720" y="1041840"/>
            <a:ext cx="29014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514362"/>
            <a:r>
              <a:rPr lang="en-US" altLang="en-US" sz="800" dirty="0">
                <a:solidFill>
                  <a:srgbClr val="000000"/>
                </a:solidFill>
              </a:rPr>
              <a:t>NORF</a:t>
            </a:r>
            <a:endParaRPr lang="en-US" altLang="en-US" sz="800" dirty="0"/>
          </a:p>
        </p:txBody>
      </p:sp>
      <p:sp>
        <p:nvSpPr>
          <p:cNvPr id="41" name="Rectangle 181"/>
          <p:cNvSpPr>
            <a:spLocks noChangeArrowheads="1"/>
          </p:cNvSpPr>
          <p:nvPr/>
        </p:nvSpPr>
        <p:spPr bwMode="auto">
          <a:xfrm>
            <a:off x="1321206" y="1041840"/>
            <a:ext cx="29014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514362"/>
            <a:r>
              <a:rPr lang="en-US" altLang="en-US" sz="800" dirty="0">
                <a:solidFill>
                  <a:srgbClr val="000000"/>
                </a:solidFill>
              </a:rPr>
              <a:t>NORF</a:t>
            </a:r>
            <a:endParaRPr lang="en-US" altLang="en-US" sz="800" dirty="0"/>
          </a:p>
        </p:txBody>
      </p:sp>
      <p:sp>
        <p:nvSpPr>
          <p:cNvPr id="42" name="Rectangle 182"/>
          <p:cNvSpPr>
            <a:spLocks noChangeArrowheads="1"/>
          </p:cNvSpPr>
          <p:nvPr/>
        </p:nvSpPr>
        <p:spPr bwMode="auto">
          <a:xfrm>
            <a:off x="1871485" y="1041840"/>
            <a:ext cx="27892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514362"/>
            <a:r>
              <a:rPr lang="en-US" altLang="en-US" sz="800" dirty="0">
                <a:solidFill>
                  <a:srgbClr val="000000"/>
                </a:solidFill>
              </a:rPr>
              <a:t>FORF</a:t>
            </a:r>
            <a:endParaRPr lang="en-US" altLang="en-US" sz="800" dirty="0"/>
          </a:p>
        </p:txBody>
      </p:sp>
      <p:sp>
        <p:nvSpPr>
          <p:cNvPr id="52" name="TextBox 51"/>
          <p:cNvSpPr txBox="1"/>
          <p:nvPr/>
        </p:nvSpPr>
        <p:spPr>
          <a:xfrm>
            <a:off x="586506" y="812855"/>
            <a:ext cx="5982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8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434414" y="811562"/>
            <a:ext cx="5822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8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/>
          <p:cNvCxnSpPr/>
          <p:nvPr/>
        </p:nvCxnSpPr>
        <p:spPr>
          <a:xfrm flipH="1">
            <a:off x="1222038" y="1031912"/>
            <a:ext cx="106680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>
            <a:off x="662601" y="1031912"/>
            <a:ext cx="49752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56" name="Table 55">
            <a:extLst>
              <a:ext uri="{FF2B5EF4-FFF2-40B4-BE49-F238E27FC236}">
                <a16:creationId xmlns:a16="http://schemas.microsoft.com/office/drawing/2014/main" id="{82B49CFB-E212-D3C4-F865-D9DD9ACDE1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8932642"/>
              </p:ext>
            </p:extLst>
          </p:nvPr>
        </p:nvGraphicFramePr>
        <p:xfrm>
          <a:off x="630676" y="1515382"/>
          <a:ext cx="1685757" cy="182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1919">
                  <a:extLst>
                    <a:ext uri="{9D8B030D-6E8A-4147-A177-3AD203B41FA5}">
                      <a16:colId xmlns:a16="http://schemas.microsoft.com/office/drawing/2014/main" val="653196475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3540232337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16983717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5735323"/>
                  </a:ext>
                </a:extLst>
              </a:tr>
            </a:tbl>
          </a:graphicData>
        </a:graphic>
      </p:graphicFrame>
      <p:graphicFrame>
        <p:nvGraphicFramePr>
          <p:cNvPr id="57" name="Table 56">
            <a:extLst>
              <a:ext uri="{FF2B5EF4-FFF2-40B4-BE49-F238E27FC236}">
                <a16:creationId xmlns:a16="http://schemas.microsoft.com/office/drawing/2014/main" id="{2974835B-7173-1403-DB61-EF248DF408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4189325"/>
              </p:ext>
            </p:extLst>
          </p:nvPr>
        </p:nvGraphicFramePr>
        <p:xfrm>
          <a:off x="626890" y="2039769"/>
          <a:ext cx="1685757" cy="182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1919">
                  <a:extLst>
                    <a:ext uri="{9D8B030D-6E8A-4147-A177-3AD203B41FA5}">
                      <a16:colId xmlns:a16="http://schemas.microsoft.com/office/drawing/2014/main" val="653196475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3540232337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16983717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8±0.17</a:t>
                      </a:r>
                      <a:endParaRPr lang="en-GB" sz="6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endParaRPr lang="en-GB" sz="6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0±0.07</a:t>
                      </a:r>
                      <a:endParaRPr lang="en-GB" sz="6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5735323"/>
                  </a:ext>
                </a:extLst>
              </a:tr>
            </a:tbl>
          </a:graphicData>
        </a:graphic>
      </p:graphicFrame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8C5B5111-3D34-D42C-6939-56A81A1EAA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3317196"/>
              </p:ext>
            </p:extLst>
          </p:nvPr>
        </p:nvGraphicFramePr>
        <p:xfrm>
          <a:off x="633280" y="2533306"/>
          <a:ext cx="1685757" cy="182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1919">
                  <a:extLst>
                    <a:ext uri="{9D8B030D-6E8A-4147-A177-3AD203B41FA5}">
                      <a16:colId xmlns:a16="http://schemas.microsoft.com/office/drawing/2014/main" val="653196475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3540232337"/>
                    </a:ext>
                  </a:extLst>
                </a:gridCol>
                <a:gridCol w="561919">
                  <a:extLst>
                    <a:ext uri="{9D8B030D-6E8A-4147-A177-3AD203B41FA5}">
                      <a16:colId xmlns:a16="http://schemas.microsoft.com/office/drawing/2014/main" val="169837177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6±0.24</a:t>
                      </a:r>
                      <a:endParaRPr lang="en-GB" sz="6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endParaRPr lang="en-GB" sz="600" b="1" kern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600" b="1" kern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5±0.0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65735323"/>
                  </a:ext>
                </a:extLst>
              </a:tr>
            </a:tbl>
          </a:graphicData>
        </a:graphic>
      </p:graphicFrame>
      <p:pic>
        <p:nvPicPr>
          <p:cNvPr id="59" name="Picture 58">
            <a:extLst>
              <a:ext uri="{FF2B5EF4-FFF2-40B4-BE49-F238E27FC236}">
                <a16:creationId xmlns:a16="http://schemas.microsoft.com/office/drawing/2014/main" id="{011582B7-A656-19F5-9CAB-72F38503B2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37" t="43749" r="38928" b="50096"/>
          <a:stretch/>
        </p:blipFill>
        <p:spPr>
          <a:xfrm>
            <a:off x="668485" y="2761746"/>
            <a:ext cx="1650552" cy="28765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42E75600-AE04-8DFA-05EE-02D035B0A1C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63" t="53352" r="44107" b="41568"/>
          <a:stretch/>
        </p:blipFill>
        <p:spPr>
          <a:xfrm>
            <a:off x="661876" y="1740667"/>
            <a:ext cx="1654468" cy="28919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1" name="Picture 60" descr="A close up of a test&#10;&#10;Description automatically generated">
            <a:extLst>
              <a:ext uri="{FF2B5EF4-FFF2-40B4-BE49-F238E27FC236}">
                <a16:creationId xmlns:a16="http://schemas.microsoft.com/office/drawing/2014/main" id="{A5103D56-1D34-C20F-AED0-5F51F3E056B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79" t="54567" r="44798" b="39868"/>
          <a:stretch/>
        </p:blipFill>
        <p:spPr>
          <a:xfrm>
            <a:off x="667386" y="1195301"/>
            <a:ext cx="1645043" cy="31145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3F1AC804-5F26-97B1-3C13-76FD648FDAC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30" t="32188" r="57431" b="64702"/>
          <a:stretch/>
        </p:blipFill>
        <p:spPr>
          <a:xfrm>
            <a:off x="663160" y="2251593"/>
            <a:ext cx="1663572" cy="2786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FBCC7DC3-F0AB-66F9-F200-7C958AAD9F59}"/>
              </a:ext>
            </a:extLst>
          </p:cNvPr>
          <p:cNvSpPr txBox="1"/>
          <p:nvPr/>
        </p:nvSpPr>
        <p:spPr>
          <a:xfrm>
            <a:off x="2331703" y="2761157"/>
            <a:ext cx="8455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grpSp>
        <p:nvGrpSpPr>
          <p:cNvPr id="66" name="Group 65"/>
          <p:cNvGrpSpPr/>
          <p:nvPr/>
        </p:nvGrpSpPr>
        <p:grpSpPr>
          <a:xfrm>
            <a:off x="85614" y="3364594"/>
            <a:ext cx="3564700" cy="3087128"/>
            <a:chOff x="0" y="3329614"/>
            <a:chExt cx="3564700" cy="3087128"/>
          </a:xfrm>
        </p:grpSpPr>
        <p:sp>
          <p:nvSpPr>
            <p:cNvPr id="67" name="TextBox 66"/>
            <p:cNvSpPr txBox="1"/>
            <p:nvPr/>
          </p:nvSpPr>
          <p:spPr>
            <a:xfrm>
              <a:off x="0" y="3329614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8" name="Group 67"/>
            <p:cNvGrpSpPr/>
            <p:nvPr/>
          </p:nvGrpSpPr>
          <p:grpSpPr>
            <a:xfrm>
              <a:off x="318379" y="3530232"/>
              <a:ext cx="3246321" cy="2886510"/>
              <a:chOff x="3309229" y="1129932"/>
              <a:chExt cx="3246321" cy="2886510"/>
            </a:xfrm>
          </p:grpSpPr>
          <p:graphicFrame>
            <p:nvGraphicFramePr>
              <p:cNvPr id="77" name="Chart 7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02334827"/>
                  </p:ext>
                </p:extLst>
              </p:nvPr>
            </p:nvGraphicFramePr>
            <p:xfrm>
              <a:off x="3309229" y="1129932"/>
              <a:ext cx="3246321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79" name="TextBox 78"/>
              <p:cNvSpPr txBox="1"/>
              <p:nvPr/>
            </p:nvSpPr>
            <p:spPr>
              <a:xfrm>
                <a:off x="3790786" y="3728184"/>
                <a:ext cx="6367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asc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4647145" y="3733093"/>
                <a:ext cx="7782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Viment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5486647" y="3739443"/>
                <a:ext cx="95891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-Cadherin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" name="Straight Connector 84"/>
              <p:cNvCxnSpPr/>
              <p:nvPr/>
            </p:nvCxnSpPr>
            <p:spPr>
              <a:xfrm>
                <a:off x="5974976" y="2945163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5743338" y="2811812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5055468" y="2757042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4823830" y="2299841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>
                <a:off x="4120267" y="2338737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>
                <a:off x="3888629" y="2922158"/>
                <a:ext cx="20296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/>
              <p:cNvSpPr txBox="1"/>
              <p:nvPr/>
            </p:nvSpPr>
            <p:spPr>
              <a:xfrm rot="16200000">
                <a:off x="5653038" y="2500283"/>
                <a:ext cx="3786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0.030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 rot="16200000">
                <a:off x="5888874" y="2637744"/>
                <a:ext cx="3786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01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 rot="16200000">
                <a:off x="4737459" y="1988813"/>
                <a:ext cx="3786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0.007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 rot="16200000">
                <a:off x="4969916" y="2450125"/>
                <a:ext cx="3786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18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3776628" y="2591165"/>
                <a:ext cx="42030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0.001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 rot="16200000">
                <a:off x="4036687" y="2038053"/>
                <a:ext cx="3786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24</a:t>
                </a:r>
                <a:endParaRPr 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9" name="Rectangle 223"/>
            <p:cNvSpPr>
              <a:spLocks noChangeArrowheads="1"/>
            </p:cNvSpPr>
            <p:nvPr/>
          </p:nvSpPr>
          <p:spPr bwMode="auto">
            <a:xfrm rot="16200000">
              <a:off x="-647606" y="4795468"/>
              <a:ext cx="17729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514362"/>
              <a:r>
                <a:rPr lang="en-US" altLang="en-US" sz="1200" dirty="0" smtClean="0">
                  <a:solidFill>
                    <a:srgbClr val="000000"/>
                  </a:solidFill>
                </a:rPr>
                <a:t>Protein level (fold change)</a:t>
              </a:r>
              <a:endParaRPr lang="en-US" altLang="en-US" sz="1200" dirty="0"/>
            </a:p>
          </p:txBody>
        </p:sp>
      </p:grpSp>
      <p:sp>
        <p:nvSpPr>
          <p:cNvPr id="4" name="Rectangle 3"/>
          <p:cNvSpPr/>
          <p:nvPr/>
        </p:nvSpPr>
        <p:spPr>
          <a:xfrm>
            <a:off x="232135" y="6643464"/>
            <a:ext cx="642012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sz="1200" dirty="0" smtClean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and B: Reduced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xpression of mesenchymal and increased epithelial markers following fascin knockdown in MDA-MB-231 cells. A) Representative western blot images showing the expression of fascin,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imentin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E-Cadherin in MDA-MB-231 cells following fascin manipulation. B) Bar graph showing quantitation of the indicated proteins following fascin manipulation. Results showing the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an±SD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f triplicates after normalization to GAPDH. Fascin was normalized to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</a:t>
            </a:r>
            <a:r>
              <a:rPr lang="en-US" sz="1200" baseline="300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, while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imentin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E-Cadherin were normalized to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</a:t>
            </a:r>
            <a:r>
              <a:rPr lang="en-US" sz="1200" baseline="300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26788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763467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A6CE8950-C951-795A-D5AF-259AE6B9CB10}"/>
              </a:ext>
            </a:extLst>
          </p:cNvPr>
          <p:cNvGrpSpPr/>
          <p:nvPr/>
        </p:nvGrpSpPr>
        <p:grpSpPr>
          <a:xfrm>
            <a:off x="463215" y="707508"/>
            <a:ext cx="4627450" cy="2935267"/>
            <a:chOff x="961056" y="520131"/>
            <a:chExt cx="4627450" cy="2935267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074A025-76C3-31F6-8967-3AA323397A68}"/>
                </a:ext>
              </a:extLst>
            </p:cNvPr>
            <p:cNvSpPr/>
            <p:nvPr/>
          </p:nvSpPr>
          <p:spPr>
            <a:xfrm>
              <a:off x="961056" y="670130"/>
              <a:ext cx="1414715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N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F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448)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030A89C-6768-4CE5-7658-E5AA4284E5B8}"/>
                </a:ext>
              </a:extLst>
            </p:cNvPr>
            <p:cNvSpPr/>
            <p:nvPr/>
          </p:nvSpPr>
          <p:spPr>
            <a:xfrm>
              <a:off x="4262226" y="752576"/>
              <a:ext cx="1326280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F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s+NORF</a:t>
              </a:r>
              <a:endParaRPr lang="en-US" sz="1200" kern="0" baseline="300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288)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CD989D0-8EE9-9603-30C5-0C95371A7FBD}"/>
                </a:ext>
              </a:extLst>
            </p:cNvPr>
            <p:cNvGrpSpPr/>
            <p:nvPr/>
          </p:nvGrpSpPr>
          <p:grpSpPr>
            <a:xfrm>
              <a:off x="1840626" y="520131"/>
              <a:ext cx="2833140" cy="2690734"/>
              <a:chOff x="1840626" y="520131"/>
              <a:chExt cx="2833140" cy="2690734"/>
            </a:xfrm>
          </p:grpSpPr>
          <p:pic>
            <p:nvPicPr>
              <p:cNvPr id="5" name="Picture 4" descr="A diagram of a color scheme&#10;&#10;Description automatically generated with medium confidence">
                <a:extLst>
                  <a:ext uri="{FF2B5EF4-FFF2-40B4-BE49-F238E27FC236}">
                    <a16:creationId xmlns:a16="http://schemas.microsoft.com/office/drawing/2014/main" id="{0E890ED9-02B4-6EFC-1E3F-F93D7C1711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578" t="-4450" r="32210" b="3428"/>
              <a:stretch/>
            </p:blipFill>
            <p:spPr>
              <a:xfrm>
                <a:off x="1840626" y="520131"/>
                <a:ext cx="2833140" cy="2690734"/>
              </a:xfrm>
              <a:prstGeom prst="ellipse">
                <a:avLst/>
              </a:prstGeom>
            </p:spPr>
          </p:pic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D13A5C85-850E-4C0A-BC88-7C410DFA9F82}"/>
                  </a:ext>
                </a:extLst>
              </p:cNvPr>
              <p:cNvSpPr/>
              <p:nvPr/>
            </p:nvSpPr>
            <p:spPr>
              <a:xfrm>
                <a:off x="3978253" y="2870616"/>
                <a:ext cx="263963" cy="21735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0A180AA-FB24-CE45-8910-834E01F8BC17}"/>
                </a:ext>
              </a:extLst>
            </p:cNvPr>
            <p:cNvSpPr/>
            <p:nvPr/>
          </p:nvSpPr>
          <p:spPr>
            <a:xfrm>
              <a:off x="3879425" y="2720549"/>
              <a:ext cx="1378820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N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)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s+NORF</a:t>
              </a:r>
              <a:endParaRPr lang="en-US" sz="1200" kern="0" baseline="300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272)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234950" y="3957155"/>
            <a:ext cx="6394450" cy="7940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2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enn diagram showing the significantly dysregulated metabolites in cell pellets following fascin manipulation in MDA-MB-231. The number of metabolites that are common or significantly dysregulated between the 3 groups (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re displayed. Moderated t-test p &lt; 0.05, FC 1.5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58221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2818963" y="7620"/>
            <a:ext cx="1236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B718569-9DC5-27B2-FEC1-7175CD8CADD7}"/>
              </a:ext>
            </a:extLst>
          </p:cNvPr>
          <p:cNvGrpSpPr/>
          <p:nvPr/>
        </p:nvGrpSpPr>
        <p:grpSpPr>
          <a:xfrm>
            <a:off x="420551" y="695051"/>
            <a:ext cx="4099641" cy="3523712"/>
            <a:chOff x="176002" y="4331386"/>
            <a:chExt cx="4099641" cy="3523712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B911B985-5E7E-31C1-5F34-1E677854F4F2}"/>
                </a:ext>
              </a:extLst>
            </p:cNvPr>
            <p:cNvGrpSpPr/>
            <p:nvPr/>
          </p:nvGrpSpPr>
          <p:grpSpPr>
            <a:xfrm>
              <a:off x="176002" y="4331386"/>
              <a:ext cx="3164098" cy="3523712"/>
              <a:chOff x="2637264" y="289331"/>
              <a:chExt cx="5025067" cy="4924749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2724CD9B-3DC8-0A78-0FB6-F207BE1FE1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417" t="6273" r="15753" b="10692"/>
              <a:stretch/>
            </p:blipFill>
            <p:spPr>
              <a:xfrm>
                <a:off x="3366058" y="574627"/>
                <a:ext cx="4121834" cy="4065564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EB3FA74-BD21-9CE7-8C98-89044B417688}"/>
                  </a:ext>
                </a:extLst>
              </p:cNvPr>
              <p:cNvSpPr txBox="1"/>
              <p:nvPr/>
            </p:nvSpPr>
            <p:spPr>
              <a:xfrm>
                <a:off x="3742516" y="4547280"/>
                <a:ext cx="3703342" cy="32261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−20                 0                20               40 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D93D3F21-520C-BDC7-A4D0-72C2ACD9AF87}"/>
                  </a:ext>
                </a:extLst>
              </p:cNvPr>
              <p:cNvSpPr txBox="1"/>
              <p:nvPr/>
            </p:nvSpPr>
            <p:spPr>
              <a:xfrm>
                <a:off x="3014868" y="492492"/>
                <a:ext cx="513235" cy="4147700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−40              −20                 0                  20                40    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27FD1DA-1776-AFAD-853F-2B5237558F76}"/>
                  </a:ext>
                </a:extLst>
              </p:cNvPr>
              <p:cNvSpPr txBox="1"/>
              <p:nvPr/>
            </p:nvSpPr>
            <p:spPr>
              <a:xfrm>
                <a:off x="3726456" y="4869961"/>
                <a:ext cx="2735440" cy="34411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mponent 1 (34.6 %)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6337031-30EE-4CDD-5BB4-5BA9CD5EBD5C}"/>
                  </a:ext>
                </a:extLst>
              </p:cNvPr>
              <p:cNvSpPr txBox="1"/>
              <p:nvPr/>
            </p:nvSpPr>
            <p:spPr>
              <a:xfrm>
                <a:off x="2637264" y="1440174"/>
                <a:ext cx="537675" cy="2146439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mponent 2 (15.1 %)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88D6B2E8-8404-9869-96C2-1F1C43E4D4CF}"/>
                  </a:ext>
                </a:extLst>
              </p:cNvPr>
              <p:cNvSpPr txBox="1"/>
              <p:nvPr/>
            </p:nvSpPr>
            <p:spPr>
              <a:xfrm>
                <a:off x="4844839" y="289331"/>
                <a:ext cx="1274746" cy="34411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core Plot </a:t>
                </a:r>
              </a:p>
            </p:txBody>
          </p:sp>
          <p:sp>
            <p:nvSpPr>
              <p:cNvPr id="37" name="Oval 36">
                <a:extLst>
                  <a:ext uri="{FF2B5EF4-FFF2-40B4-BE49-F238E27FC236}">
                    <a16:creationId xmlns:a16="http://schemas.microsoft.com/office/drawing/2014/main" id="{D753E4E1-4322-1E01-33CC-905A9D73C288}"/>
                  </a:ext>
                </a:extLst>
              </p:cNvPr>
              <p:cNvSpPr/>
              <p:nvPr/>
            </p:nvSpPr>
            <p:spPr>
              <a:xfrm>
                <a:off x="7493519" y="907318"/>
                <a:ext cx="168812" cy="125565"/>
              </a:xfrm>
              <a:prstGeom prst="ellipse">
                <a:avLst/>
              </a:prstGeom>
              <a:solidFill>
                <a:srgbClr val="FAD1DB"/>
              </a:solidFill>
              <a:ln>
                <a:solidFill>
                  <a:srgbClr val="F287A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8" name="Oval 37">
                <a:extLst>
                  <a:ext uri="{FF2B5EF4-FFF2-40B4-BE49-F238E27FC236}">
                    <a16:creationId xmlns:a16="http://schemas.microsoft.com/office/drawing/2014/main" id="{765A251F-E304-6531-29FF-FC2DC89B86BD}"/>
                  </a:ext>
                </a:extLst>
              </p:cNvPr>
              <p:cNvSpPr/>
              <p:nvPr/>
            </p:nvSpPr>
            <p:spPr>
              <a:xfrm>
                <a:off x="7487892" y="1117801"/>
                <a:ext cx="168813" cy="125565"/>
              </a:xfrm>
              <a:prstGeom prst="ellipse">
                <a:avLst/>
              </a:prstGeom>
              <a:solidFill>
                <a:srgbClr val="C7DFCA"/>
              </a:solidFill>
              <a:ln>
                <a:solidFill>
                  <a:srgbClr val="9BD9A2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39" name="Oval 38">
                <a:extLst>
                  <a:ext uri="{FF2B5EF4-FFF2-40B4-BE49-F238E27FC236}">
                    <a16:creationId xmlns:a16="http://schemas.microsoft.com/office/drawing/2014/main" id="{D85406F5-4867-3EEC-F120-94480B36CD9D}"/>
                  </a:ext>
                </a:extLst>
              </p:cNvPr>
              <p:cNvSpPr/>
              <p:nvPr/>
            </p:nvSpPr>
            <p:spPr>
              <a:xfrm>
                <a:off x="7487892" y="1305964"/>
                <a:ext cx="168813" cy="125565"/>
              </a:xfrm>
              <a:prstGeom prst="ellipse">
                <a:avLst/>
              </a:prstGeom>
              <a:solidFill>
                <a:srgbClr val="DFE4F8"/>
              </a:solidFill>
              <a:ln>
                <a:solidFill>
                  <a:srgbClr val="AFBDEF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7889B6E7-D94D-3507-5692-1F85B3478E44}"/>
                </a:ext>
              </a:extLst>
            </p:cNvPr>
            <p:cNvSpPr txBox="1"/>
            <p:nvPr/>
          </p:nvSpPr>
          <p:spPr>
            <a:xfrm>
              <a:off x="3312741" y="4707491"/>
              <a:ext cx="962902" cy="5078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ascin</a:t>
              </a:r>
              <a:r>
                <a:rPr lang="en-US" sz="9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KD+FORF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ascin</a:t>
              </a:r>
              <a:r>
                <a:rPr lang="en-US" sz="9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KD+NORF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ascin</a:t>
              </a:r>
              <a:r>
                <a:rPr lang="en-US" sz="900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pos+NORF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234950" y="4568414"/>
            <a:ext cx="6407150" cy="618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LS-DA showed clear separation in MDA-MB-231 cell secretomes following fascin knockdown and restoration. PLS-DA analysis of cell secretomes showing separation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roups.</a:t>
            </a:r>
          </a:p>
        </p:txBody>
      </p:sp>
    </p:spTree>
    <p:extLst>
      <p:ext uri="{BB962C8B-B14F-4D97-AF65-F5344CB8AC3E}">
        <p14:creationId xmlns:p14="http://schemas.microsoft.com/office/powerpoint/2010/main" val="3517005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9DF30BA8-02AA-63E3-8DEA-1CB2D47182F0}"/>
              </a:ext>
            </a:extLst>
          </p:cNvPr>
          <p:cNvGrpSpPr/>
          <p:nvPr/>
        </p:nvGrpSpPr>
        <p:grpSpPr>
          <a:xfrm>
            <a:off x="209800" y="4327208"/>
            <a:ext cx="3116329" cy="3028340"/>
            <a:chOff x="5539611" y="72783"/>
            <a:chExt cx="5340277" cy="5174558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CC1B0B9-25C7-6303-62BD-23F5C09CE7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02" t="5303" r="16371" b="10432"/>
            <a:stretch/>
          </p:blipFill>
          <p:spPr>
            <a:xfrm>
              <a:off x="6260124" y="432856"/>
              <a:ext cx="4290646" cy="4196427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CD67B73-88A5-D269-2697-9E5361CEAAB0}"/>
                </a:ext>
              </a:extLst>
            </p:cNvPr>
            <p:cNvGrpSpPr/>
            <p:nvPr/>
          </p:nvGrpSpPr>
          <p:grpSpPr>
            <a:xfrm>
              <a:off x="10705449" y="882350"/>
              <a:ext cx="174439" cy="349361"/>
              <a:chOff x="9517263" y="4439126"/>
              <a:chExt cx="174439" cy="349361"/>
            </a:xfrm>
          </p:grpSpPr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E934687A-D967-4FE6-5407-22D7C78C87B9}"/>
                  </a:ext>
                </a:extLst>
              </p:cNvPr>
              <p:cNvSpPr/>
              <p:nvPr/>
            </p:nvSpPr>
            <p:spPr>
              <a:xfrm>
                <a:off x="9522890" y="4439126"/>
                <a:ext cx="168812" cy="125565"/>
              </a:xfrm>
              <a:prstGeom prst="ellipse">
                <a:avLst/>
              </a:prstGeom>
              <a:solidFill>
                <a:srgbClr val="FAD1DB"/>
              </a:solidFill>
              <a:ln>
                <a:solidFill>
                  <a:srgbClr val="F287A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20A15377-B7FB-71EF-E0D8-544D18F5EC48}"/>
                  </a:ext>
                </a:extLst>
              </p:cNvPr>
              <p:cNvSpPr/>
              <p:nvPr/>
            </p:nvSpPr>
            <p:spPr>
              <a:xfrm>
                <a:off x="9517263" y="4662922"/>
                <a:ext cx="168812" cy="125565"/>
              </a:xfrm>
              <a:prstGeom prst="ellipse">
                <a:avLst/>
              </a:prstGeom>
              <a:solidFill>
                <a:srgbClr val="C7DFCA"/>
              </a:solidFill>
              <a:ln>
                <a:solidFill>
                  <a:srgbClr val="9BD9A2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01F48D9-7CBB-A005-F3EE-DED7C4B1A1FD}"/>
                </a:ext>
              </a:extLst>
            </p:cNvPr>
            <p:cNvSpPr txBox="1"/>
            <p:nvPr/>
          </p:nvSpPr>
          <p:spPr>
            <a:xfrm>
              <a:off x="6096000" y="4564596"/>
              <a:ext cx="4609447" cy="39442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−60     −40      −20         0         20        40        6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513DC3F-D1D4-F4C8-E78C-58638EBBB657}"/>
                </a:ext>
              </a:extLst>
            </p:cNvPr>
            <p:cNvSpPr txBox="1"/>
            <p:nvPr/>
          </p:nvSpPr>
          <p:spPr>
            <a:xfrm>
              <a:off x="5914710" y="604912"/>
              <a:ext cx="553790" cy="3787631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−100       −50          0           50        100   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26C0245-BCEF-7C66-C06B-888BBD89F8C9}"/>
                </a:ext>
              </a:extLst>
            </p:cNvPr>
            <p:cNvSpPr txBox="1"/>
            <p:nvPr/>
          </p:nvSpPr>
          <p:spPr>
            <a:xfrm>
              <a:off x="7265666" y="4826620"/>
              <a:ext cx="2206816" cy="4207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 score [1] (50%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AA8CF0C-DF40-88C7-FBEB-F59135EDC825}"/>
                </a:ext>
              </a:extLst>
            </p:cNvPr>
            <p:cNvSpPr txBox="1"/>
            <p:nvPr/>
          </p:nvSpPr>
          <p:spPr>
            <a:xfrm>
              <a:off x="5539611" y="968854"/>
              <a:ext cx="580161" cy="321220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rthogonal T score [1] (18.6 %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E062D7B-A41C-9105-4900-6A4D8E2B0BE3}"/>
                </a:ext>
              </a:extLst>
            </p:cNvPr>
            <p:cNvSpPr txBox="1"/>
            <p:nvPr/>
          </p:nvSpPr>
          <p:spPr>
            <a:xfrm>
              <a:off x="7713334" y="72783"/>
              <a:ext cx="1329484" cy="4207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core Plot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3D72EC2-AB63-71B1-B25A-97C905DB22AE}"/>
                </a:ext>
              </a:extLst>
            </p:cNvPr>
            <p:cNvSpPr txBox="1"/>
            <p:nvPr/>
          </p:nvSpPr>
          <p:spPr>
            <a:xfrm>
              <a:off x="6508034" y="4220120"/>
              <a:ext cx="2746719" cy="39442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Q2=0. 898       R2Y=0.999 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9F84E47-0A55-946F-897B-56B6EFCA1450}"/>
              </a:ext>
            </a:extLst>
          </p:cNvPr>
          <p:cNvGrpSpPr/>
          <p:nvPr/>
        </p:nvGrpSpPr>
        <p:grpSpPr>
          <a:xfrm>
            <a:off x="232181" y="882137"/>
            <a:ext cx="2939068" cy="3203203"/>
            <a:chOff x="126725" y="406888"/>
            <a:chExt cx="5225013" cy="488652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D326397-CC07-D6C9-B1B1-63C2EE3F4E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68" t="6068" r="7965" b="14718"/>
            <a:stretch/>
          </p:blipFill>
          <p:spPr>
            <a:xfrm>
              <a:off x="892279" y="407963"/>
              <a:ext cx="4459459" cy="4332851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DFDF258-D266-B2F1-5833-B92D5CAD4097}"/>
                </a:ext>
              </a:extLst>
            </p:cNvPr>
            <p:cNvSpPr txBox="1"/>
            <p:nvPr/>
          </p:nvSpPr>
          <p:spPr>
            <a:xfrm>
              <a:off x="890101" y="4668595"/>
              <a:ext cx="4313222" cy="35213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−4           −2            0            2             4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BCC3B54-ECAE-7CD0-65FC-ADD272A1377C}"/>
                </a:ext>
              </a:extLst>
            </p:cNvPr>
            <p:cNvSpPr txBox="1"/>
            <p:nvPr/>
          </p:nvSpPr>
          <p:spPr>
            <a:xfrm>
              <a:off x="466848" y="406888"/>
              <a:ext cx="574516" cy="440833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0                   1                   2                    3                   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3440593-8062-2621-48A4-F2F52234EE66}"/>
                </a:ext>
              </a:extLst>
            </p:cNvPr>
            <p:cNvSpPr txBox="1"/>
            <p:nvPr/>
          </p:nvSpPr>
          <p:spPr>
            <a:xfrm>
              <a:off x="1989800" y="4917795"/>
              <a:ext cx="2153921" cy="37561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og2(Fold change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32648B5-21F4-EE97-FB18-EA027DEF29F7}"/>
                </a:ext>
              </a:extLst>
            </p:cNvPr>
            <p:cNvSpPr txBox="1"/>
            <p:nvPr/>
          </p:nvSpPr>
          <p:spPr>
            <a:xfrm>
              <a:off x="126725" y="1761864"/>
              <a:ext cx="601874" cy="1684606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log10(d P value)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7889B6E7-D94D-3507-5692-1F85B3478E44}"/>
              </a:ext>
            </a:extLst>
          </p:cNvPr>
          <p:cNvSpPr txBox="1"/>
          <p:nvPr/>
        </p:nvSpPr>
        <p:spPr>
          <a:xfrm>
            <a:off x="3303571" y="4718391"/>
            <a:ext cx="962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KD+N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os+N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387243" y="7620"/>
            <a:ext cx="2099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4A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nd 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0" y="6357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30" y="42820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232180" y="7459134"/>
            <a:ext cx="6403569" cy="13203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4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and B: Dysregulated metabolites in MDA-MB-231 secretomes following fascin knockdown. A) Volcano plot showing the 3804 significantly dysregulated metabolites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, with 1397 and 2407 metabolites were up- (red) and down- (blue) regulated, respectively. B) OPLS-DA model shows evident separation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. The robustness of the created models was evaluated by the fitness of model (R2Y=0.999) and predictive ability (Q2=0.898) values in a larger dataset (n=100).</a:t>
            </a:r>
          </a:p>
        </p:txBody>
      </p:sp>
    </p:spTree>
    <p:extLst>
      <p:ext uri="{BB962C8B-B14F-4D97-AF65-F5344CB8AC3E}">
        <p14:creationId xmlns:p14="http://schemas.microsoft.com/office/powerpoint/2010/main" val="2828833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93F4D386-29C9-DAFE-09FA-D6C41EE124AA}"/>
              </a:ext>
            </a:extLst>
          </p:cNvPr>
          <p:cNvGrpSpPr/>
          <p:nvPr/>
        </p:nvGrpSpPr>
        <p:grpSpPr>
          <a:xfrm>
            <a:off x="231798" y="4320040"/>
            <a:ext cx="2884782" cy="2885920"/>
            <a:chOff x="6457148" y="399078"/>
            <a:chExt cx="4967798" cy="507102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C93A96A-23CA-2A88-84DA-853DD695B5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04" t="4985" r="16171" b="10396"/>
            <a:stretch/>
          </p:blipFill>
          <p:spPr>
            <a:xfrm>
              <a:off x="7138682" y="762055"/>
              <a:ext cx="4079632" cy="4057886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ECDC3E37-A240-A7C7-F6B2-7F7CAD604745}"/>
                </a:ext>
              </a:extLst>
            </p:cNvPr>
            <p:cNvGrpSpPr/>
            <p:nvPr/>
          </p:nvGrpSpPr>
          <p:grpSpPr>
            <a:xfrm>
              <a:off x="11276415" y="1131830"/>
              <a:ext cx="148531" cy="349361"/>
              <a:chOff x="9517263" y="4439126"/>
              <a:chExt cx="174439" cy="349361"/>
            </a:xfrm>
          </p:grpSpPr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A8EBC436-1CD4-C124-0FC7-F6DFBE29EB31}"/>
                  </a:ext>
                </a:extLst>
              </p:cNvPr>
              <p:cNvSpPr/>
              <p:nvPr/>
            </p:nvSpPr>
            <p:spPr>
              <a:xfrm>
                <a:off x="9522890" y="4439126"/>
                <a:ext cx="168812" cy="125565"/>
              </a:xfrm>
              <a:prstGeom prst="ellipse">
                <a:avLst/>
              </a:prstGeom>
              <a:solidFill>
                <a:srgbClr val="FAD1DB"/>
              </a:solidFill>
              <a:ln>
                <a:solidFill>
                  <a:srgbClr val="F287A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5C17CC8C-7F29-5E61-D530-D83FCE58BCA6}"/>
                  </a:ext>
                </a:extLst>
              </p:cNvPr>
              <p:cNvSpPr/>
              <p:nvPr/>
            </p:nvSpPr>
            <p:spPr>
              <a:xfrm>
                <a:off x="9517263" y="4662922"/>
                <a:ext cx="168812" cy="125565"/>
              </a:xfrm>
              <a:prstGeom prst="ellipse">
                <a:avLst/>
              </a:prstGeom>
              <a:solidFill>
                <a:srgbClr val="C7DFCA"/>
              </a:solidFill>
              <a:ln>
                <a:solidFill>
                  <a:srgbClr val="9BD9A2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13"/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A9B99AD-095B-F81F-9354-B2F230C6DCE4}"/>
                </a:ext>
              </a:extLst>
            </p:cNvPr>
            <p:cNvSpPr txBox="1"/>
            <p:nvPr/>
          </p:nvSpPr>
          <p:spPr>
            <a:xfrm>
              <a:off x="7246228" y="4743948"/>
              <a:ext cx="3972085" cy="40560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−40         −20           0           20          4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5E2B8B7-62EB-867A-752E-8D28D8854C70}"/>
                </a:ext>
              </a:extLst>
            </p:cNvPr>
            <p:cNvSpPr txBox="1"/>
            <p:nvPr/>
          </p:nvSpPr>
          <p:spPr>
            <a:xfrm>
              <a:off x="6801845" y="835362"/>
              <a:ext cx="556513" cy="3460896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−50                  0                  50            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EF0BA1A-FAAB-9E95-C7CC-2049857D060B}"/>
                </a:ext>
              </a:extLst>
            </p:cNvPr>
            <p:cNvSpPr txBox="1"/>
            <p:nvPr/>
          </p:nvSpPr>
          <p:spPr>
            <a:xfrm>
              <a:off x="8137503" y="5037450"/>
              <a:ext cx="2206816" cy="4326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 score [1] (27.3%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36096BF-E61F-19A5-2F9E-E9B4B2AB2E94}"/>
                </a:ext>
              </a:extLst>
            </p:cNvPr>
            <p:cNvSpPr txBox="1"/>
            <p:nvPr/>
          </p:nvSpPr>
          <p:spPr>
            <a:xfrm>
              <a:off x="6457148" y="1140430"/>
              <a:ext cx="583014" cy="3342467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rthogonal T score [1] (17.3 %)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A6F83FA-0E99-5AB9-F9AF-98167266DC26}"/>
                </a:ext>
              </a:extLst>
            </p:cNvPr>
            <p:cNvSpPr txBox="1"/>
            <p:nvPr/>
          </p:nvSpPr>
          <p:spPr>
            <a:xfrm>
              <a:off x="8510183" y="399078"/>
              <a:ext cx="1368101" cy="43265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core Plot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1FA20D2-1BE1-590E-55AA-609E3222969C}"/>
                </a:ext>
              </a:extLst>
            </p:cNvPr>
            <p:cNvSpPr txBox="1"/>
            <p:nvPr/>
          </p:nvSpPr>
          <p:spPr>
            <a:xfrm>
              <a:off x="7484015" y="4413195"/>
              <a:ext cx="2746718" cy="41036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Q2=0. 498       R2Y=0.997 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80F7727-03E1-E5C4-1C31-CFEA6A6F2B43}"/>
              </a:ext>
            </a:extLst>
          </p:cNvPr>
          <p:cNvGrpSpPr/>
          <p:nvPr/>
        </p:nvGrpSpPr>
        <p:grpSpPr>
          <a:xfrm>
            <a:off x="241568" y="749290"/>
            <a:ext cx="2792834" cy="3238041"/>
            <a:chOff x="498993" y="233418"/>
            <a:chExt cx="4965039" cy="493321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39473F0-B7DE-F0D9-ED3D-3036A7D779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53" t="5953" r="6088" b="15794"/>
            <a:stretch/>
          </p:blipFill>
          <p:spPr>
            <a:xfrm>
              <a:off x="1243583" y="377039"/>
              <a:ext cx="4146250" cy="4285644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A550F67-204E-086A-4746-8266504BB054}"/>
                </a:ext>
              </a:extLst>
            </p:cNvPr>
            <p:cNvSpPr txBox="1"/>
            <p:nvPr/>
          </p:nvSpPr>
          <p:spPr>
            <a:xfrm>
              <a:off x="866591" y="4551905"/>
              <a:ext cx="4597441" cy="3516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−4    −3    −2    −1       0      1       2       3      4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2CA8AE1-F414-AF03-7142-05E94C6645BE}"/>
                </a:ext>
              </a:extLst>
            </p:cNvPr>
            <p:cNvSpPr txBox="1"/>
            <p:nvPr/>
          </p:nvSpPr>
          <p:spPr>
            <a:xfrm>
              <a:off x="883964" y="233418"/>
              <a:ext cx="574516" cy="4421596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0                    1                     2                     3             4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75A5E98-74B4-A5B5-CD2D-64A436D88044}"/>
                </a:ext>
              </a:extLst>
            </p:cNvPr>
            <p:cNvSpPr txBox="1"/>
            <p:nvPr/>
          </p:nvSpPr>
          <p:spPr>
            <a:xfrm>
              <a:off x="2293443" y="4814959"/>
              <a:ext cx="2015037" cy="3516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g2(Fold change)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4DCAF53-E759-279E-4D4D-99B1C42058B2}"/>
                </a:ext>
              </a:extLst>
            </p:cNvPr>
            <p:cNvSpPr txBox="1"/>
            <p:nvPr/>
          </p:nvSpPr>
          <p:spPr>
            <a:xfrm>
              <a:off x="498993" y="1461409"/>
              <a:ext cx="601874" cy="168460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log10(d P value)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7889B6E7-D94D-3507-5692-1F85B3478E44}"/>
              </a:ext>
            </a:extLst>
          </p:cNvPr>
          <p:cNvSpPr txBox="1"/>
          <p:nvPr/>
        </p:nvSpPr>
        <p:spPr>
          <a:xfrm>
            <a:off x="3082048" y="4655592"/>
            <a:ext cx="962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KD+F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KD+N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0" y="6357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330" y="42820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387243" y="7620"/>
            <a:ext cx="2099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5A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nd B</a:t>
            </a:r>
          </a:p>
        </p:txBody>
      </p:sp>
      <p:sp>
        <p:nvSpPr>
          <p:cNvPr id="2" name="Rectangle 1"/>
          <p:cNvSpPr/>
          <p:nvPr/>
        </p:nvSpPr>
        <p:spPr>
          <a:xfrm>
            <a:off x="241568" y="7375233"/>
            <a:ext cx="6381482" cy="13203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5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and B: Dysregulated metabolites in MDA-MB-231 secretomes following fascin restoration in the knockdown cells. A) Volcano plot showing the 452 significantly dysregulated metabolites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, with 205 and 247 metabolites were up- (red) and down- (blue) regulated, respectively. B) OPLS-DA model shows evident separation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. The robustness of the created models was evaluated by the fitness of model (R2Y=0.997) and predictive ability (Q2=0.498) values in a larger dataset (n=100).</a:t>
            </a:r>
          </a:p>
        </p:txBody>
      </p:sp>
    </p:spTree>
    <p:extLst>
      <p:ext uri="{BB962C8B-B14F-4D97-AF65-F5344CB8AC3E}">
        <p14:creationId xmlns:p14="http://schemas.microsoft.com/office/powerpoint/2010/main" val="24390358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0D601B4F-923A-1DF6-2954-6216083014CF}"/>
              </a:ext>
            </a:extLst>
          </p:cNvPr>
          <p:cNvGrpSpPr/>
          <p:nvPr/>
        </p:nvGrpSpPr>
        <p:grpSpPr>
          <a:xfrm>
            <a:off x="275754" y="838200"/>
            <a:ext cx="2733225" cy="3138682"/>
            <a:chOff x="275641" y="537276"/>
            <a:chExt cx="4859067" cy="4753343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C53FB78-DDEC-F898-66D7-183A4B1B22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39" t="5956" r="5536" b="15794"/>
            <a:stretch/>
          </p:blipFill>
          <p:spPr>
            <a:xfrm>
              <a:off x="961805" y="618977"/>
              <a:ext cx="4172903" cy="413590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05FAD74C-3E0C-A830-AD24-9146C08D73D1}"/>
                </a:ext>
              </a:extLst>
            </p:cNvPr>
            <p:cNvSpPr txBox="1"/>
            <p:nvPr/>
          </p:nvSpPr>
          <p:spPr>
            <a:xfrm>
              <a:off x="961805" y="4654747"/>
              <a:ext cx="3880878" cy="3495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 −4          −2           0           2            4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43712396-1D53-3746-E9D7-9ED71F1517F5}"/>
                </a:ext>
              </a:extLst>
            </p:cNvPr>
            <p:cNvSpPr txBox="1"/>
            <p:nvPr/>
          </p:nvSpPr>
          <p:spPr>
            <a:xfrm>
              <a:off x="565643" y="537276"/>
              <a:ext cx="574516" cy="427530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0                  1                   2                  3                   4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FAC54E4-4D0A-2F3A-1617-9271B16E794E}"/>
                </a:ext>
              </a:extLst>
            </p:cNvPr>
            <p:cNvSpPr txBox="1"/>
            <p:nvPr/>
          </p:nvSpPr>
          <p:spPr>
            <a:xfrm>
              <a:off x="1896436" y="4917732"/>
              <a:ext cx="2260722" cy="372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og2(Fold change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4FA9F18-A213-9DF6-3985-0D57C5807222}"/>
                </a:ext>
              </a:extLst>
            </p:cNvPr>
            <p:cNvSpPr txBox="1"/>
            <p:nvPr/>
          </p:nvSpPr>
          <p:spPr>
            <a:xfrm>
              <a:off x="275641" y="1838265"/>
              <a:ext cx="601874" cy="1684607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log10(d P value)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CE3C4C74-41CE-8B83-69F1-7E2405F71B4F}"/>
              </a:ext>
            </a:extLst>
          </p:cNvPr>
          <p:cNvGrpSpPr/>
          <p:nvPr/>
        </p:nvGrpSpPr>
        <p:grpSpPr>
          <a:xfrm>
            <a:off x="210799" y="4319926"/>
            <a:ext cx="2913401" cy="2962273"/>
            <a:chOff x="6313895" y="225552"/>
            <a:chExt cx="4947070" cy="5041528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C2DCF05-588E-3945-86DB-96A15919D1CD}"/>
                </a:ext>
              </a:extLst>
            </p:cNvPr>
            <p:cNvGrpSpPr/>
            <p:nvPr/>
          </p:nvGrpSpPr>
          <p:grpSpPr>
            <a:xfrm>
              <a:off x="6313895" y="225552"/>
              <a:ext cx="4947070" cy="5041528"/>
              <a:chOff x="6313895" y="225552"/>
              <a:chExt cx="4947070" cy="5041528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DC2CBF0-9062-61DF-22F8-4498C39289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22" t="5497" r="15595" b="9616"/>
              <a:stretch/>
            </p:blipFill>
            <p:spPr>
              <a:xfrm>
                <a:off x="7061023" y="596989"/>
                <a:ext cx="4025503" cy="4021592"/>
              </a:xfrm>
              <a:prstGeom prst="rect">
                <a:avLst/>
              </a:prstGeom>
            </p:spPr>
          </p:pic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205033F5-1E0A-6A94-11AE-2D63D1DC0081}"/>
                  </a:ext>
                </a:extLst>
              </p:cNvPr>
              <p:cNvGrpSpPr/>
              <p:nvPr/>
            </p:nvGrpSpPr>
            <p:grpSpPr>
              <a:xfrm>
                <a:off x="11086526" y="920735"/>
                <a:ext cx="174439" cy="349361"/>
                <a:chOff x="9517263" y="4439126"/>
                <a:chExt cx="174439" cy="349361"/>
              </a:xfrm>
            </p:grpSpPr>
            <p:sp>
              <p:nvSpPr>
                <p:cNvPr id="15" name="Oval 14">
                  <a:extLst>
                    <a:ext uri="{FF2B5EF4-FFF2-40B4-BE49-F238E27FC236}">
                      <a16:creationId xmlns:a16="http://schemas.microsoft.com/office/drawing/2014/main" id="{8D67F7CF-E684-AF0B-9F50-9CDAAE4DD672}"/>
                    </a:ext>
                  </a:extLst>
                </p:cNvPr>
                <p:cNvSpPr/>
                <p:nvPr/>
              </p:nvSpPr>
              <p:spPr>
                <a:xfrm>
                  <a:off x="9522890" y="4439126"/>
                  <a:ext cx="168812" cy="125565"/>
                </a:xfrm>
                <a:prstGeom prst="ellipse">
                  <a:avLst/>
                </a:prstGeom>
                <a:solidFill>
                  <a:srgbClr val="FAD1DB"/>
                </a:solidFill>
                <a:ln>
                  <a:solidFill>
                    <a:srgbClr val="F287A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3"/>
                </a:p>
              </p:txBody>
            </p:sp>
            <p:sp>
              <p:nvSpPr>
                <p:cNvPr id="17" name="Oval 16">
                  <a:extLst>
                    <a:ext uri="{FF2B5EF4-FFF2-40B4-BE49-F238E27FC236}">
                      <a16:creationId xmlns:a16="http://schemas.microsoft.com/office/drawing/2014/main" id="{19A8BD44-504D-2A61-168C-8BDB4ACB9EEB}"/>
                    </a:ext>
                  </a:extLst>
                </p:cNvPr>
                <p:cNvSpPr/>
                <p:nvPr/>
              </p:nvSpPr>
              <p:spPr>
                <a:xfrm>
                  <a:off x="9517263" y="4662922"/>
                  <a:ext cx="168812" cy="125565"/>
                </a:xfrm>
                <a:prstGeom prst="ellipse">
                  <a:avLst/>
                </a:prstGeom>
                <a:solidFill>
                  <a:srgbClr val="C7DFCA"/>
                </a:solidFill>
                <a:ln>
                  <a:solidFill>
                    <a:srgbClr val="9BD9A2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13"/>
                </a:p>
              </p:txBody>
            </p:sp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1BDA0661-2005-5343-7C10-FF3C7F4ABC26}"/>
                  </a:ext>
                </a:extLst>
              </p:cNvPr>
              <p:cNvSpPr txBox="1"/>
              <p:nvPr/>
            </p:nvSpPr>
            <p:spPr>
              <a:xfrm>
                <a:off x="7197456" y="4528157"/>
                <a:ext cx="3916861" cy="39285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−40       −20           0          20          40         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EAFC83F-B0BB-375E-4CBC-8516515F7781}"/>
                  </a:ext>
                </a:extLst>
              </p:cNvPr>
              <p:cNvSpPr txBox="1"/>
              <p:nvPr/>
            </p:nvSpPr>
            <p:spPr>
              <a:xfrm>
                <a:off x="6687795" y="532145"/>
                <a:ext cx="548747" cy="4086435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−100        −50             0            50          100    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5DB18A4-5D22-58D9-711F-057E8CA3276B}"/>
                  </a:ext>
                </a:extLst>
              </p:cNvPr>
              <p:cNvSpPr txBox="1"/>
              <p:nvPr/>
            </p:nvSpPr>
            <p:spPr>
              <a:xfrm>
                <a:off x="7971618" y="4848033"/>
                <a:ext cx="2206816" cy="41904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 score [1] (34.7%)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748B02D-37B0-2440-FE28-98AA69E27B3C}"/>
                  </a:ext>
                </a:extLst>
              </p:cNvPr>
              <p:cNvSpPr txBox="1"/>
              <p:nvPr/>
            </p:nvSpPr>
            <p:spPr>
              <a:xfrm>
                <a:off x="6313895" y="1091448"/>
                <a:ext cx="574878" cy="2993713"/>
              </a:xfrm>
              <a:prstGeom prst="rect">
                <a:avLst/>
              </a:prstGeom>
              <a:noFill/>
            </p:spPr>
            <p:txBody>
              <a:bodyPr vert="vert270"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rthogonal T score [1] (17 %)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5E387EF-C6BC-926E-0A06-9128B6F9F090}"/>
                  </a:ext>
                </a:extLst>
              </p:cNvPr>
              <p:cNvSpPr txBox="1"/>
              <p:nvPr/>
            </p:nvSpPr>
            <p:spPr>
              <a:xfrm>
                <a:off x="8430550" y="225552"/>
                <a:ext cx="1321034" cy="41904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core Plot 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D8F5FC0-8209-571A-73F9-7DB910BCAC6D}"/>
                </a:ext>
              </a:extLst>
            </p:cNvPr>
            <p:cNvSpPr txBox="1"/>
            <p:nvPr/>
          </p:nvSpPr>
          <p:spPr>
            <a:xfrm>
              <a:off x="7282683" y="4179734"/>
              <a:ext cx="2746720" cy="39285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Q2=0. 733       R2Y=0.999 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7889B6E7-D94D-3507-5692-1F85B3478E44}"/>
              </a:ext>
            </a:extLst>
          </p:cNvPr>
          <p:cNvSpPr txBox="1"/>
          <p:nvPr/>
        </p:nvSpPr>
        <p:spPr>
          <a:xfrm>
            <a:off x="3071178" y="4644039"/>
            <a:ext cx="962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os+N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ascin</a:t>
            </a:r>
            <a:r>
              <a:rPr lang="en-US" sz="9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KD+FORF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387240" y="7620"/>
            <a:ext cx="2099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6A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nd 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0" y="63578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3330" y="428202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Rectangle 3"/>
          <p:cNvSpPr/>
          <p:nvPr/>
        </p:nvSpPr>
        <p:spPr>
          <a:xfrm>
            <a:off x="210799" y="7514292"/>
            <a:ext cx="6424951" cy="13203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6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and B: Dysregulated metabolites in MDA-MB-231 supernatants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. A) Volcano plot showing the 802 significantly dysregulated metabolites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, with 252 and 550 metabolites were up- (red) and down- (blue) regulated, respectively. B) OPLS-DA model shows evident separation between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ells. The robustness of the created models was evaluated by the fitness of model (R2Y=0.999) and predictive ability (Q2=0.733) values in a larger dataset (n=100).</a:t>
            </a:r>
          </a:p>
        </p:txBody>
      </p:sp>
    </p:spTree>
    <p:extLst>
      <p:ext uri="{BB962C8B-B14F-4D97-AF65-F5344CB8AC3E}">
        <p14:creationId xmlns:p14="http://schemas.microsoft.com/office/powerpoint/2010/main" val="8870999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818962" y="762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412C2C23-13D1-FF46-5EE4-48B5F9DA05A9}"/>
              </a:ext>
            </a:extLst>
          </p:cNvPr>
          <p:cNvGrpSpPr/>
          <p:nvPr/>
        </p:nvGrpSpPr>
        <p:grpSpPr>
          <a:xfrm>
            <a:off x="290981" y="774765"/>
            <a:ext cx="5081608" cy="2799282"/>
            <a:chOff x="2162779" y="3304901"/>
            <a:chExt cx="5081608" cy="2799282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86226F44-6181-F519-8536-3DFE1A04FD4B}"/>
                </a:ext>
              </a:extLst>
            </p:cNvPr>
            <p:cNvSpPr/>
            <p:nvPr/>
          </p:nvSpPr>
          <p:spPr>
            <a:xfrm>
              <a:off x="2162779" y="3539697"/>
              <a:ext cx="1338012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N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s+NORF</a:t>
              </a:r>
              <a:endParaRPr lang="en-US" sz="1200" kern="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528)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8D9896D2-BCE0-8238-B334-EC7893739F10}"/>
                </a:ext>
              </a:extLst>
            </p:cNvPr>
            <p:cNvSpPr/>
            <p:nvPr/>
          </p:nvSpPr>
          <p:spPr>
            <a:xfrm>
              <a:off x="5892672" y="3539697"/>
              <a:ext cx="1351715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F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os+NORF</a:t>
              </a:r>
              <a:endParaRPr lang="en-US" sz="1200" kern="0" baseline="3000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133)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14" descr="A diagram of a circle&#10;&#10;Description automatically generated with medium confidence">
              <a:extLst>
                <a:ext uri="{FF2B5EF4-FFF2-40B4-BE49-F238E27FC236}">
                  <a16:creationId xmlns:a16="http://schemas.microsoft.com/office/drawing/2014/main" id="{E68D4FB1-40AE-3F3D-4E99-E7D57A43E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63" t="-3533" r="31535" b="3310"/>
            <a:stretch/>
          </p:blipFill>
          <p:spPr>
            <a:xfrm>
              <a:off x="3190322" y="3304901"/>
              <a:ext cx="2949597" cy="2503357"/>
            </a:xfrm>
            <a:prstGeom prst="ellipse">
              <a:avLst/>
            </a:prstGeom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764D415-8083-98B4-3A6D-B9F98489818D}"/>
                </a:ext>
              </a:extLst>
            </p:cNvPr>
            <p:cNvSpPr/>
            <p:nvPr/>
          </p:nvSpPr>
          <p:spPr>
            <a:xfrm>
              <a:off x="5415379" y="5459767"/>
              <a:ext cx="355106" cy="3484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4D9E3DBF-40FF-48DD-10D5-6C49C12DF20E}"/>
                </a:ext>
              </a:extLst>
            </p:cNvPr>
            <p:cNvSpPr/>
            <p:nvPr/>
          </p:nvSpPr>
          <p:spPr>
            <a:xfrm>
              <a:off x="5319109" y="5369334"/>
              <a:ext cx="1328654" cy="7348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N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vs </a:t>
              </a:r>
              <a:r>
                <a:rPr lang="en-US" sz="1200" kern="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ascin</a:t>
              </a:r>
              <a:r>
                <a:rPr lang="en-US" sz="1200" kern="0" baseline="30000" dirty="0" err="1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D+FORF</a:t>
              </a:r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kern="0" dirty="0">
                  <a:solidFill>
                    <a:schemeClr val="tx1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n= 49) </a:t>
              </a:r>
              <a:endPara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234950" y="3804180"/>
            <a:ext cx="6407150" cy="7940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7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enn diagram showing the significantly dysregulated metabolites in secretomes following fascin manipulation in MDA-MB-231. The number of metabolites that are common or significantly dysregulated between the 3 groups (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pos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N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ascinKD+FORF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re displayed. Moderated t-test p &lt; 0.05, FC 1.5.</a:t>
            </a:r>
          </a:p>
        </p:txBody>
      </p:sp>
    </p:spTree>
    <p:extLst>
      <p:ext uri="{BB962C8B-B14F-4D97-AF65-F5344CB8AC3E}">
        <p14:creationId xmlns:p14="http://schemas.microsoft.com/office/powerpoint/2010/main" val="41795290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F3E5E169-28A4-293C-5522-E3278990FA8B}"/>
              </a:ext>
            </a:extLst>
          </p:cNvPr>
          <p:cNvSpPr/>
          <p:nvPr/>
        </p:nvSpPr>
        <p:spPr>
          <a:xfrm>
            <a:off x="2007087" y="2742832"/>
            <a:ext cx="1060918" cy="42170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kern="0" dirty="0">
                <a:solidFill>
                  <a:schemeClr val="tx1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l pellets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 623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C8A393F9-2B3B-8FCD-5642-EBFF6564FEE6}"/>
              </a:ext>
            </a:extLst>
          </p:cNvPr>
          <p:cNvSpPr/>
          <p:nvPr/>
        </p:nvSpPr>
        <p:spPr>
          <a:xfrm>
            <a:off x="1088655" y="2743214"/>
            <a:ext cx="1031465" cy="42170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retomes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 594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18962" y="762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13598" y="896963"/>
            <a:ext cx="3091364" cy="1958147"/>
            <a:chOff x="513598" y="896963"/>
            <a:chExt cx="3091364" cy="195814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17989B0-3023-A1CB-ED4A-3AA614FB21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106" r="29079" b="18764"/>
            <a:stretch/>
          </p:blipFill>
          <p:spPr>
            <a:xfrm>
              <a:off x="677779" y="896963"/>
              <a:ext cx="2817568" cy="1845486"/>
            </a:xfrm>
            <a:prstGeom prst="rect">
              <a:avLst/>
            </a:prstGeom>
          </p:spPr>
        </p:pic>
        <p:sp>
          <p:nvSpPr>
            <p:cNvPr id="2" name="Oval 1"/>
            <p:cNvSpPr/>
            <p:nvPr/>
          </p:nvSpPr>
          <p:spPr>
            <a:xfrm>
              <a:off x="3276600" y="2308860"/>
              <a:ext cx="328362" cy="51054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Oval 9"/>
            <p:cNvSpPr/>
            <p:nvPr/>
          </p:nvSpPr>
          <p:spPr>
            <a:xfrm>
              <a:off x="513598" y="2344570"/>
              <a:ext cx="328362" cy="51054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" name="Rectangle 3"/>
          <p:cNvSpPr/>
          <p:nvPr/>
        </p:nvSpPr>
        <p:spPr>
          <a:xfrm>
            <a:off x="241300" y="3644897"/>
            <a:ext cx="6369050" cy="7940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8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Venn diagram showing the significantly dysregulated metabolites between MDA-MB-231 cell pellets and secretomes. The diagram shows 230 common metabolites among the 623 and 594 significantly dysregulated metabolites in the cell pellets and secretomes, respectively. Moderated t-test p &lt; 0.05, FC 1.5.</a:t>
            </a:r>
          </a:p>
        </p:txBody>
      </p:sp>
    </p:spTree>
    <p:extLst>
      <p:ext uri="{BB962C8B-B14F-4D97-AF65-F5344CB8AC3E}">
        <p14:creationId xmlns:p14="http://schemas.microsoft.com/office/powerpoint/2010/main" val="31979527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818962" y="7620"/>
            <a:ext cx="1236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12238" y="611257"/>
            <a:ext cx="4666690" cy="3096118"/>
            <a:chOff x="212238" y="611257"/>
            <a:chExt cx="4666690" cy="3096118"/>
          </a:xfrm>
        </p:grpSpPr>
        <p:grpSp>
          <p:nvGrpSpPr>
            <p:cNvPr id="5" name="Group 4"/>
            <p:cNvGrpSpPr/>
            <p:nvPr/>
          </p:nvGrpSpPr>
          <p:grpSpPr>
            <a:xfrm>
              <a:off x="212238" y="611257"/>
              <a:ext cx="4666690" cy="3096118"/>
              <a:chOff x="212238" y="611257"/>
              <a:chExt cx="4666690" cy="3096118"/>
            </a:xfrm>
          </p:grpSpPr>
          <p:pic>
            <p:nvPicPr>
              <p:cNvPr id="4" name="Picture 3" descr="Chart, scatter chart, bubble chart&#10;&#10;Description automatically generated">
                <a:extLst>
                  <a:ext uri="{FF2B5EF4-FFF2-40B4-BE49-F238E27FC236}">
                    <a16:creationId xmlns:a16="http://schemas.microsoft.com/office/drawing/2014/main" id="{9DC1766F-5D2E-85C2-FE28-AD4EAEC1AD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483" b="14467"/>
              <a:stretch/>
            </p:blipFill>
            <p:spPr>
              <a:xfrm>
                <a:off x="635000" y="611257"/>
                <a:ext cx="2779150" cy="2716143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08C44E9-51E0-8DC3-700A-5773CE4F64E4}"/>
                  </a:ext>
                </a:extLst>
              </p:cNvPr>
              <p:cNvSpPr txBox="1"/>
              <p:nvPr/>
            </p:nvSpPr>
            <p:spPr>
              <a:xfrm>
                <a:off x="2473038" y="740428"/>
                <a:ext cx="1880359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Glycerophospholipid metabolism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887A667-E750-B492-46EA-1620C6BE0F4C}"/>
                  </a:ext>
                </a:extLst>
              </p:cNvPr>
              <p:cNvSpPr txBox="1"/>
              <p:nvPr/>
            </p:nvSpPr>
            <p:spPr>
              <a:xfrm>
                <a:off x="3102930" y="2036739"/>
                <a:ext cx="177599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ylalanine, tyrosine and tryptophan biosynthesis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FB1990C-629A-BD20-88EF-011037B4EDA3}"/>
                  </a:ext>
                </a:extLst>
              </p:cNvPr>
              <p:cNvSpPr txBox="1"/>
              <p:nvPr/>
            </p:nvSpPr>
            <p:spPr>
              <a:xfrm>
                <a:off x="3143929" y="2416912"/>
                <a:ext cx="1734999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nate and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hosphinate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metabolism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C74B125-F473-91DF-950C-A7B16850F266}"/>
                  </a:ext>
                </a:extLst>
              </p:cNvPr>
              <p:cNvSpPr txBox="1"/>
              <p:nvPr/>
            </p:nvSpPr>
            <p:spPr>
              <a:xfrm>
                <a:off x="2124547" y="1675281"/>
                <a:ext cx="1423780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yrosine metabolism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9FB6C80-8D22-5441-6A48-DAAE72ACF144}"/>
                  </a:ext>
                </a:extLst>
              </p:cNvPr>
              <p:cNvSpPr txBox="1"/>
              <p:nvPr/>
            </p:nvSpPr>
            <p:spPr>
              <a:xfrm>
                <a:off x="780900" y="1467532"/>
                <a:ext cx="1634366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rachidonic acid metabolism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3FEE4133-A4CC-BB5C-B52A-DA56C91D71D5}"/>
                  </a:ext>
                </a:extLst>
              </p:cNvPr>
              <p:cNvSpPr txBox="1"/>
              <p:nvPr/>
            </p:nvSpPr>
            <p:spPr>
              <a:xfrm>
                <a:off x="1368758" y="1837098"/>
                <a:ext cx="2456208" cy="2308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orphyrin and chlorophyll metabolism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2F9698F-FFBC-D8F3-412C-1D3BA77F33A3}"/>
                  </a:ext>
                </a:extLst>
              </p:cNvPr>
              <p:cNvSpPr txBox="1"/>
              <p:nvPr/>
            </p:nvSpPr>
            <p:spPr>
              <a:xfrm>
                <a:off x="1489167" y="2030942"/>
                <a:ext cx="1775998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ysteine and methionine metabolism</a:t>
                </a: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1330658" y="3461154"/>
                <a:ext cx="1091966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thway Impact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-12663" y="1943469"/>
                <a:ext cx="69602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log10(p)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59BECDC-3870-82A5-252D-BD4A835097E2}"/>
                </a:ext>
              </a:extLst>
            </p:cNvPr>
            <p:cNvSpPr txBox="1"/>
            <p:nvPr/>
          </p:nvSpPr>
          <p:spPr>
            <a:xfrm>
              <a:off x="412257" y="806450"/>
              <a:ext cx="461665" cy="2542074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.0         0.5          1.0         1.5          2.0         2.5                4           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21B83AB-6B33-5A31-6A24-28642738D5D8}"/>
                </a:ext>
              </a:extLst>
            </p:cNvPr>
            <p:cNvSpPr txBox="1"/>
            <p:nvPr/>
          </p:nvSpPr>
          <p:spPr>
            <a:xfrm>
              <a:off x="601977" y="3284815"/>
              <a:ext cx="2663187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.0         0.1          0.2         0.3         0.4          0.5  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212238" y="4031393"/>
            <a:ext cx="6398112" cy="618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9. 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thway analysis for the significantly dysregulated metabolites in cell pellets and secretomes of MDA-MB-231 following fascin manipulation. Variation in colors (yellow to red) indicates increase in the significance level of the dysregulated metabolites.</a:t>
            </a:r>
          </a:p>
        </p:txBody>
      </p:sp>
    </p:spTree>
    <p:extLst>
      <p:ext uri="{BB962C8B-B14F-4D97-AF65-F5344CB8AC3E}">
        <p14:creationId xmlns:p14="http://schemas.microsoft.com/office/powerpoint/2010/main" val="3846833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509</TotalTime>
  <Words>992</Words>
  <Application>Microsoft Office PowerPoint</Application>
  <PresentationFormat>Letter Paper (8.5x11 in)</PresentationFormat>
  <Paragraphs>12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SimSun</vt:lpstr>
      <vt:lpstr>Arial</vt:lpstr>
      <vt:lpstr>Calibri</vt:lpstr>
      <vt:lpstr>Calibri Light</vt:lpstr>
      <vt:lpstr>Palatino Linotype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abolomics Profile of MDA-MB-231 cells and supernatants</dc:title>
  <dc:creator>ريم المالكي ID 439203044</dc:creator>
  <cp:lastModifiedBy>ALALWAN, MONTHER MOHAMED</cp:lastModifiedBy>
  <cp:revision>264</cp:revision>
  <dcterms:created xsi:type="dcterms:W3CDTF">2022-10-01T17:45:44Z</dcterms:created>
  <dcterms:modified xsi:type="dcterms:W3CDTF">2024-07-18T06:52:25Z</dcterms:modified>
</cp:coreProperties>
</file>